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B2D11-6945-41F6-88BA-F4AEC4E78C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71B44-C707-48EB-BDD5-6232EBFDA4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94CE7-9A5F-48A1-B8C3-87624C5798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5B4F1-6A45-40EE-B102-F3F22078D6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5FDBC-BFC6-434D-B2D9-BBA7A95B4D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A7C79-4E07-4777-9099-01688E3B47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D924F-A2B7-4F1E-801C-7D601E343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41912-5211-4907-914B-D384C79391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337C9-2B6A-48A0-BAB9-C225C5B551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E3A45-E2FD-4C86-9320-A7C4561827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4A0BA-7FC7-4585-8EA9-8F1EB62C8F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63D06-A885-4595-97F2-CD08119476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AE4DA3-1793-4268-9D8C-F3111EAA662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22400" y="833400"/>
            <a:ext cx="7648560" cy="307080"/>
            <a:chOff x="1022400" y="833400"/>
            <a:chExt cx="7648560" cy="307080"/>
          </a:xfrm>
        </p:grpSpPr>
        <p:sp>
          <p:nvSpPr>
            <p:cNvPr id="42" name=""/>
            <p:cNvSpPr/>
            <p:nvPr/>
          </p:nvSpPr>
          <p:spPr>
            <a:xfrm>
              <a:off x="1022400" y="833400"/>
              <a:ext cx="15303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Tg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1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548080" y="833400"/>
              <a:ext cx="15303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Tg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2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083120" y="833400"/>
              <a:ext cx="15303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1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613480" y="833400"/>
              <a:ext cx="15303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2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140600" y="833400"/>
              <a:ext cx="15303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3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47" name=""/>
          <p:cNvGraphicFramePr/>
          <p:nvPr/>
        </p:nvGraphicFramePr>
        <p:xfrm>
          <a:off x="482760" y="1465200"/>
          <a:ext cx="7843680" cy="5283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82760" y="1465200"/>
                    <a:ext cx="7843680" cy="528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>
            <a:off x="3353760" y="1116000"/>
            <a:ext cx="254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ile Acid Synthesi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039680" y="47520"/>
            <a:ext cx="718056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To What Degree the Differentiated Expressed Genes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are Enriched for Each Dataset within this Pathway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 flipV="1">
            <a:off x="7381440" y="1130400"/>
            <a:ext cx="390600" cy="3888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971040" y="1479600"/>
            <a:ext cx="186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oaded CRI 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3" name=""/>
          <p:cNvGraphicFramePr/>
          <p:nvPr/>
        </p:nvGraphicFramePr>
        <p:xfrm>
          <a:off x="2427120" y="1090440"/>
          <a:ext cx="6532560" cy="5596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27120" y="1090440"/>
                    <a:ext cx="6532560" cy="559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5" name=""/>
          <p:cNvGrpSpPr/>
          <p:nvPr/>
        </p:nvGrpSpPr>
        <p:grpSpPr>
          <a:xfrm>
            <a:off x="1944720" y="682560"/>
            <a:ext cx="7046640" cy="307080"/>
            <a:chOff x="1944720" y="682560"/>
            <a:chExt cx="7046640" cy="307080"/>
          </a:xfrm>
        </p:grpSpPr>
        <p:sp>
          <p:nvSpPr>
            <p:cNvPr id="56" name=""/>
            <p:cNvSpPr/>
            <p:nvPr/>
          </p:nvSpPr>
          <p:spPr>
            <a:xfrm>
              <a:off x="1944720" y="682560"/>
              <a:ext cx="14097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Tg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1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350160" y="682560"/>
              <a:ext cx="14097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Tg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2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764600" y="682560"/>
              <a:ext cx="141120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1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175800" y="682560"/>
              <a:ext cx="140832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2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581600" y="682560"/>
              <a:ext cx="1409760" cy="307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G5G8</a:t>
              </a:r>
              <a:r>
                <a:rPr b="1" lang="en-US" sz="1400" spc="-1" strike="noStrike" baseline="30000">
                  <a:solidFill>
                    <a:srgbClr val="808080"/>
                  </a:solidFill>
                  <a:latin typeface="Arial"/>
                </a:rPr>
                <a:t>-/-</a:t>
              </a:r>
              <a:r>
                <a:rPr b="1" lang="en-US" sz="1400" spc="-1" strike="noStrike">
                  <a:solidFill>
                    <a:srgbClr val="808080"/>
                  </a:solidFill>
                  <a:latin typeface="Arial"/>
                </a:rPr>
                <a:t>3Liv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"/>
          <p:cNvSpPr/>
          <p:nvPr/>
        </p:nvSpPr>
        <p:spPr>
          <a:xfrm>
            <a:off x="72720" y="1919160"/>
            <a:ext cx="2149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lor Templ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anel vs CRI 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519200" y="2529000"/>
            <a:ext cx="1020960" cy="74448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508680" y="5882760"/>
            <a:ext cx="3098160" cy="673200"/>
            <a:chOff x="508680" y="5882760"/>
            <a:chExt cx="3098160" cy="673200"/>
          </a:xfrm>
        </p:grpSpPr>
        <p:sp>
          <p:nvSpPr>
            <p:cNvPr id="64" name=""/>
            <p:cNvSpPr/>
            <p:nvPr/>
          </p:nvSpPr>
          <p:spPr>
            <a:xfrm flipV="1">
              <a:off x="1995840" y="5882760"/>
              <a:ext cx="1611000" cy="409320"/>
            </a:xfrm>
            <a:prstGeom prst="line">
              <a:avLst/>
            </a:prstGeom>
            <a:ln w="572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08680" y="5913360"/>
              <a:ext cx="16786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isher Exact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Test P-Valu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"/>
          <p:cNvGrpSpPr/>
          <p:nvPr/>
        </p:nvGrpSpPr>
        <p:grpSpPr>
          <a:xfrm>
            <a:off x="72000" y="4954680"/>
            <a:ext cx="3533040" cy="730080"/>
            <a:chOff x="72000" y="4954680"/>
            <a:chExt cx="3533040" cy="730080"/>
          </a:xfrm>
        </p:grpSpPr>
        <p:sp>
          <p:nvSpPr>
            <p:cNvPr id="67" name=""/>
            <p:cNvSpPr/>
            <p:nvPr/>
          </p:nvSpPr>
          <p:spPr>
            <a:xfrm>
              <a:off x="2008080" y="5440320"/>
              <a:ext cx="1596960" cy="244440"/>
            </a:xfrm>
            <a:prstGeom prst="line">
              <a:avLst/>
            </a:prstGeom>
            <a:ln w="572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2000" y="4954680"/>
              <a:ext cx="20491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olor to show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Range of p-Valu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"/>
          <p:cNvSpPr/>
          <p:nvPr/>
        </p:nvSpPr>
        <p:spPr>
          <a:xfrm flipV="1">
            <a:off x="1514520" y="1028520"/>
            <a:ext cx="762120" cy="990360"/>
          </a:xfrm>
          <a:prstGeom prst="line">
            <a:avLst/>
          </a:prstGeom>
          <a:ln w="57240">
            <a:solidFill>
              <a:srgbClr val="ff33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"/>
          <p:cNvGrpSpPr/>
          <p:nvPr/>
        </p:nvGrpSpPr>
        <p:grpSpPr>
          <a:xfrm>
            <a:off x="6175080" y="3616200"/>
            <a:ext cx="2287800" cy="2103480"/>
            <a:chOff x="6175080" y="3616200"/>
            <a:chExt cx="2287800" cy="2103480"/>
          </a:xfrm>
        </p:grpSpPr>
        <p:sp>
          <p:nvSpPr>
            <p:cNvPr id="71" name=""/>
            <p:cNvSpPr/>
            <p:nvPr/>
          </p:nvSpPr>
          <p:spPr>
            <a:xfrm>
              <a:off x="7653240" y="4172040"/>
              <a:ext cx="68400" cy="1547640"/>
            </a:xfrm>
            <a:prstGeom prst="line">
              <a:avLst/>
            </a:prstGeom>
            <a:ln w="572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864480" y="3616200"/>
              <a:ext cx="15984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Arial"/>
                </a:rPr>
                <a:t>Good Enrichmen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H="1">
              <a:off x="6997320" y="4173480"/>
              <a:ext cx="561960" cy="1533600"/>
            </a:xfrm>
            <a:prstGeom prst="line">
              <a:avLst/>
            </a:prstGeom>
            <a:ln w="572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H="1">
              <a:off x="6175080" y="4187880"/>
              <a:ext cx="1284120" cy="1515960"/>
            </a:xfrm>
            <a:prstGeom prst="line">
              <a:avLst/>
            </a:prstGeom>
            <a:ln w="572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"/>
          <p:cNvSpPr/>
          <p:nvPr/>
        </p:nvSpPr>
        <p:spPr>
          <a:xfrm flipV="1">
            <a:off x="1933560" y="3389400"/>
            <a:ext cx="684360" cy="226800"/>
          </a:xfrm>
          <a:prstGeom prst="line">
            <a:avLst/>
          </a:prstGeom>
          <a:ln w="572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1120" y="3292560"/>
            <a:ext cx="2012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d and gre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lors for up- o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own-regulat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0" y="0"/>
            <a:ext cx="914400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Window for “Local” Fisher’s exact test of a Colored PSCP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-To What Degree the Differentiated Expressed Genes are Enriched for each CRI?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8T03:50:59Z</dcterms:created>
  <dc:creator>Ming Yi</dc:creator>
  <dc:description/>
  <dc:language>en-US</dc:language>
  <cp:lastModifiedBy>MingYi</cp:lastModifiedBy>
  <dcterms:modified xsi:type="dcterms:W3CDTF">2005-11-09T22:19:30Z</dcterms:modified>
  <cp:revision>14</cp:revision>
  <dc:subject/>
  <dc:title>Slide 1</dc:title>
</cp:coreProperties>
</file>